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8175625" cy="57594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F4B312-620C-4479-8934-72DC5F05B9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12720" y="512640"/>
            <a:ext cx="6948720" cy="959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12720" y="1663200"/>
            <a:ext cx="694872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12720" y="3469320"/>
            <a:ext cx="694872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743C2B-32BF-4E1E-B4EA-7254D810B8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12720" y="512640"/>
            <a:ext cx="6948720" cy="959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12720" y="1663200"/>
            <a:ext cx="339084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173480" y="1663200"/>
            <a:ext cx="339084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12720" y="3469320"/>
            <a:ext cx="339084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173480" y="3469320"/>
            <a:ext cx="339084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7F30A-B496-4C39-AC3D-FB1C5B0894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12720" y="512640"/>
            <a:ext cx="6948720" cy="959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12720" y="1663200"/>
            <a:ext cx="223740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962440" y="1663200"/>
            <a:ext cx="223740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312160" y="1663200"/>
            <a:ext cx="223740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12720" y="3469320"/>
            <a:ext cx="223740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962440" y="3469320"/>
            <a:ext cx="223740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312160" y="3469320"/>
            <a:ext cx="223740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EEF877-3A73-4E51-826A-AB77D1B2B95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12720" y="512640"/>
            <a:ext cx="6948720" cy="959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12720" y="1663200"/>
            <a:ext cx="6948720" cy="3457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0E239-DD20-4008-BE72-C57BC1C928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12720" y="512640"/>
            <a:ext cx="6948720" cy="959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12720" y="1663200"/>
            <a:ext cx="6948720" cy="34578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388445-8836-45F3-BB89-C48B64FC0C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12720" y="512640"/>
            <a:ext cx="6948720" cy="959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12720" y="1663200"/>
            <a:ext cx="3390840" cy="34578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173480" y="1663200"/>
            <a:ext cx="3390840" cy="34578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9CB795-B2F1-4048-9884-7E94C7D39E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12720" y="512640"/>
            <a:ext cx="6948720" cy="959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CA8CD4-69E0-4074-980E-7ACDD3F4F3B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12720" y="512640"/>
            <a:ext cx="6948720" cy="444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00"/>
              </a:spcBef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33BAA9-5D2A-47AB-8554-30B69942B0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12720" y="512640"/>
            <a:ext cx="6948720" cy="959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12720" y="1663200"/>
            <a:ext cx="339084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173480" y="1663200"/>
            <a:ext cx="3390840" cy="34578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12720" y="3469320"/>
            <a:ext cx="339084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902086-AEF0-4A83-B1A0-9D91BB6E42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12720" y="512640"/>
            <a:ext cx="6948720" cy="959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12720" y="1663200"/>
            <a:ext cx="3390840" cy="34578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173480" y="1663200"/>
            <a:ext cx="339084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173480" y="3469320"/>
            <a:ext cx="339084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E0296C-05DE-4620-A882-5D7CAB6931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12720" y="512640"/>
            <a:ext cx="6948720" cy="959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12720" y="1663200"/>
            <a:ext cx="339084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173480" y="1663200"/>
            <a:ext cx="339084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12720" y="3469320"/>
            <a:ext cx="6948720" cy="164916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/>
          </a:bodyPr>
          <a:p>
            <a:pPr indent="0">
              <a:spcBef>
                <a:spcPts val="700"/>
              </a:spcBef>
              <a:buNone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0D2AAC-82B4-499F-A77B-2E2BEC0B66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12720" y="512640"/>
            <a:ext cx="6948720" cy="95904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ctr">
            <a:noAutofit/>
          </a:bodyPr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3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12720" y="1663200"/>
            <a:ext cx="6948720" cy="345780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rmAutofit fontScale="96000"/>
          </a:bodyPr>
          <a:p>
            <a:pPr marL="283320" indent="-28332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13800" indent="-2358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944640" indent="-189000"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324080" indent="-18900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702080" indent="-1890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702080" indent="-1890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702080" indent="-189000">
              <a:spcBef>
                <a:spcPts val="700"/>
              </a:spcBef>
              <a:buClr>
                <a:srgbClr val="000000"/>
              </a:buClr>
              <a:buFont typeface="Arial"/>
              <a:buChar char="»"/>
              <a:tabLst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12720" y="5248080"/>
            <a:ext cx="1704960" cy="384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Autofit/>
          </a:bodyPr>
          <a:lstStyle>
            <a:lvl1pPr indent="0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793960" y="5248080"/>
            <a:ext cx="2586240" cy="384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Autofit/>
          </a:bodyPr>
          <a:lstStyle>
            <a:lvl1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855760" y="5248080"/>
            <a:ext cx="1705320" cy="384120"/>
          </a:xfrm>
          <a:prstGeom prst="rect">
            <a:avLst/>
          </a:prstGeom>
          <a:noFill/>
          <a:ln w="0">
            <a:noFill/>
          </a:ln>
        </p:spPr>
        <p:txBody>
          <a:bodyPr lIns="78840" rIns="78840" tIns="39240" bIns="39240" anchor="t">
            <a:noAutofit/>
          </a:bodyPr>
          <a:lstStyle>
            <a:lvl1pPr indent="0" algn="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787320"/>
                <a:tab algn="l" pos="1574640"/>
                <a:tab algn="l" pos="2362320"/>
                <a:tab algn="l" pos="3149640"/>
                <a:tab algn="l" pos="3936960"/>
                <a:tab algn="l" pos="4724280"/>
                <a:tab algn="l" pos="5511960"/>
                <a:tab algn="l" pos="6299280"/>
                <a:tab algn="l" pos="7086600"/>
                <a:tab algn="l" pos="7873920"/>
                <a:tab algn="l" pos="8661240"/>
                <a:tab algn="l" pos="9448920"/>
                <a:tab algn="l" pos="10236240"/>
              </a:tabLst>
            </a:pPr>
            <a:fld id="{5BC23441-FA8A-49A2-ADA4-6E9B174ABCA8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3400" y="23760"/>
            <a:ext cx="8096760" cy="5688000"/>
            <a:chOff x="23400" y="23760"/>
            <a:chExt cx="8096760" cy="5688000"/>
          </a:xfrm>
        </p:grpSpPr>
        <p:sp>
          <p:nvSpPr>
            <p:cNvPr id="42" name=""/>
            <p:cNvSpPr/>
            <p:nvPr/>
          </p:nvSpPr>
          <p:spPr>
            <a:xfrm>
              <a:off x="880920" y="3325680"/>
              <a:ext cx="71640" cy="716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367000" y="3325680"/>
              <a:ext cx="90360" cy="716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616120" y="3325680"/>
              <a:ext cx="90720" cy="716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370240" y="5141880"/>
              <a:ext cx="90360" cy="716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619360" y="5141880"/>
              <a:ext cx="90360" cy="716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3568680" y="4749840"/>
              <a:ext cx="233280" cy="88596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" descr=""/>
            <p:cNvPicPr/>
            <p:nvPr/>
          </p:nvPicPr>
          <p:blipFill>
            <a:blip r:embed="rId2"/>
            <a:stretch/>
          </p:blipFill>
          <p:spPr>
            <a:xfrm>
              <a:off x="411120" y="689040"/>
              <a:ext cx="4338720" cy="2367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" descr=""/>
            <p:cNvPicPr/>
            <p:nvPr/>
          </p:nvPicPr>
          <p:blipFill>
            <a:blip r:embed="rId3"/>
            <a:stretch/>
          </p:blipFill>
          <p:spPr>
            <a:xfrm>
              <a:off x="4878360" y="490680"/>
              <a:ext cx="3241800" cy="2520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"/>
            <p:cNvSpPr/>
            <p:nvPr/>
          </p:nvSpPr>
          <p:spPr>
            <a:xfrm>
              <a:off x="112680" y="241200"/>
              <a:ext cx="8007480" cy="2841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1" name="" descr=""/>
            <p:cNvPicPr/>
            <p:nvPr/>
          </p:nvPicPr>
          <p:blipFill>
            <a:blip r:embed="rId4"/>
            <a:stretch/>
          </p:blipFill>
          <p:spPr>
            <a:xfrm>
              <a:off x="4419720" y="987480"/>
              <a:ext cx="1336680" cy="1158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"/>
            <p:cNvSpPr/>
            <p:nvPr/>
          </p:nvSpPr>
          <p:spPr>
            <a:xfrm>
              <a:off x="4830840" y="295200"/>
              <a:ext cx="51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Ctg 487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6561720" y="295200"/>
              <a:ext cx="1079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Ctg 776+4471+91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181480" y="1108080"/>
              <a:ext cx="579600" cy="106200"/>
            </a:xfrm>
            <a:prstGeom prst="rect">
              <a:avLst/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799240" y="1397160"/>
              <a:ext cx="493560" cy="106200"/>
            </a:xfrm>
            <a:prstGeom prst="rect">
              <a:avLst/>
            </a:prstGeom>
            <a:noFill/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233960" y="241200"/>
              <a:ext cx="1440" cy="1889280"/>
            </a:xfrm>
            <a:custGeom>
              <a:avLst/>
              <a:gdLst/>
              <a:ahLst/>
              <a:rect l="l" t="t" r="r" b="b"/>
              <a:pathLst>
                <a:path w="1" h="1190">
                  <a:moveTo>
                    <a:pt x="0" y="1190"/>
                  </a:moveTo>
                  <a:lnTo>
                    <a:pt x="1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233960" y="2130480"/>
              <a:ext cx="780840" cy="9360"/>
            </a:xfrm>
            <a:custGeom>
              <a:avLst/>
              <a:gdLst/>
              <a:ahLst/>
              <a:rect l="l" t="t" r="r" b="b"/>
              <a:pathLst>
                <a:path w="492" h="6">
                  <a:moveTo>
                    <a:pt x="0" y="0"/>
                  </a:moveTo>
                  <a:lnTo>
                    <a:pt x="492" y="6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37440" bIns="-374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flipV="1">
              <a:off x="4068720" y="1189080"/>
              <a:ext cx="1897200" cy="1892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flipV="1">
              <a:off x="5961240" y="240840"/>
              <a:ext cx="4680" cy="9478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flipH="1" flipV="1">
              <a:off x="5762520" y="1214280"/>
              <a:ext cx="38160" cy="1828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1" name=""/>
            <p:cNvGrpSpPr/>
            <p:nvPr/>
          </p:nvGrpSpPr>
          <p:grpSpPr>
            <a:xfrm>
              <a:off x="5516640" y="1670040"/>
              <a:ext cx="985680" cy="1258920"/>
              <a:chOff x="5516640" y="1670040"/>
              <a:chExt cx="985680" cy="1258920"/>
            </a:xfrm>
          </p:grpSpPr>
          <p:sp>
            <p:nvSpPr>
              <p:cNvPr id="62" name=""/>
              <p:cNvSpPr/>
              <p:nvPr/>
            </p:nvSpPr>
            <p:spPr>
              <a:xfrm>
                <a:off x="6373800" y="1670040"/>
                <a:ext cx="39600" cy="39600"/>
              </a:xfrm>
              <a:prstGeom prst="star5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3480" bIns="-334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6176880" y="1771560"/>
                <a:ext cx="39960" cy="39960"/>
              </a:xfrm>
              <a:prstGeom prst="star5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3120" bIns="-331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6456240" y="1866960"/>
                <a:ext cx="39960" cy="39600"/>
              </a:xfrm>
              <a:prstGeom prst="star5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3480" bIns="-334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6195960" y="2584440"/>
                <a:ext cx="39600" cy="39600"/>
              </a:xfrm>
              <a:prstGeom prst="star5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3480" bIns="-334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6323040" y="2482920"/>
                <a:ext cx="39600" cy="39600"/>
              </a:xfrm>
              <a:prstGeom prst="star5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3480" bIns="-334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6062760" y="2374920"/>
                <a:ext cx="39600" cy="39600"/>
              </a:xfrm>
              <a:prstGeom prst="star5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3480" bIns="-334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6303960" y="2279520"/>
                <a:ext cx="39600" cy="39960"/>
              </a:xfrm>
              <a:prstGeom prst="star5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3120" bIns="-331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6202440" y="2178000"/>
                <a:ext cx="39600" cy="39600"/>
              </a:xfrm>
              <a:prstGeom prst="star5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3480" bIns="-334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6323040" y="2076480"/>
                <a:ext cx="39600" cy="39600"/>
              </a:xfrm>
              <a:prstGeom prst="star5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3480" bIns="-334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6462720" y="1968480"/>
                <a:ext cx="39600" cy="39600"/>
              </a:xfrm>
              <a:prstGeom prst="star5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3480" bIns="-334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6157800" y="2685960"/>
                <a:ext cx="39960" cy="39960"/>
              </a:xfrm>
              <a:prstGeom prst="star5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3120" bIns="-3312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5757840" y="2787840"/>
                <a:ext cx="39600" cy="39600"/>
              </a:xfrm>
              <a:prstGeom prst="star5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3480" bIns="-334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5516640" y="2889360"/>
                <a:ext cx="39600" cy="39600"/>
              </a:xfrm>
              <a:prstGeom prst="star5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33480" bIns="-334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5" name=""/>
            <p:cNvSpPr/>
            <p:nvPr/>
          </p:nvSpPr>
          <p:spPr>
            <a:xfrm>
              <a:off x="465120" y="4051440"/>
              <a:ext cx="76294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493200" y="320976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636120" y="320976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670840" y="3605040"/>
              <a:ext cx="2750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(TG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738360" y="34718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2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072320" y="3738600"/>
              <a:ext cx="3513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(TTTG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4344480" y="3471840"/>
              <a:ext cx="26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2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3400" y="3321000"/>
              <a:ext cx="381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BTA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48600" y="3973680"/>
              <a:ext cx="30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HSA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66560" y="3398760"/>
              <a:ext cx="76298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405520" y="3471840"/>
              <a:ext cx="3513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(TTTG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957600" y="34718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2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062360" y="36050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2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855360" y="320976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103400" y="373860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2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405080" y="36050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3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497240" y="373860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3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592640" y="386388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3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721160" y="34718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3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281240" y="34718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2-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194120" y="386388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2-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2219040" y="320976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075120" y="34718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608640" y="34718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267800" y="3863880"/>
              <a:ext cx="26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2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683240" y="34718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5662800" y="34718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6321600" y="34718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909520" y="320688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501480" y="3325680"/>
              <a:ext cx="9072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650880" y="3325680"/>
              <a:ext cx="7128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flipV="1">
              <a:off x="566640" y="2808000"/>
              <a:ext cx="0" cy="4064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flipV="1">
              <a:off x="690480" y="2808000"/>
              <a:ext cx="0" cy="4064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flipV="1">
              <a:off x="797040" y="2789280"/>
              <a:ext cx="0" cy="5954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763560" y="335592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V="1">
              <a:off x="915840" y="2808000"/>
              <a:ext cx="0" cy="4064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V="1">
              <a:off x="1015920" y="2719080"/>
              <a:ext cx="0" cy="6476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flipV="1">
              <a:off x="1098720" y="2719080"/>
              <a:ext cx="0" cy="6476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97956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106524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501480" y="3979800"/>
              <a:ext cx="9072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641520" y="3979800"/>
              <a:ext cx="7128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75420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969840" y="401148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1055520" y="401148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1777320" y="295200"/>
              <a:ext cx="86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</a:rPr>
                <a:t>Ctg 2005+204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V="1">
              <a:off x="1185840" y="2158560"/>
              <a:ext cx="0" cy="12416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14948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flipV="1">
              <a:off x="1255680" y="2163240"/>
              <a:ext cx="0" cy="12416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 flipV="1">
              <a:off x="1324080" y="2158560"/>
              <a:ext cx="0" cy="12416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22400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29384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flipV="1">
              <a:off x="1457280" y="2077560"/>
              <a:ext cx="0" cy="12956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142416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1139760" y="401148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1217520" y="401148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152100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363680" y="3979800"/>
              <a:ext cx="5400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V="1">
              <a:off x="1644480" y="1909800"/>
              <a:ext cx="0" cy="150336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61136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V="1">
              <a:off x="1779480" y="1804680"/>
              <a:ext cx="0" cy="161748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1741320" y="335592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42416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29384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1554120" y="2075040"/>
              <a:ext cx="0" cy="129528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52100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1936800" y="34718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3-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flipV="1">
              <a:off x="1995480" y="1622160"/>
              <a:ext cx="0" cy="180972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957320" y="335592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2057760" y="36050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3-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flipV="1">
              <a:off x="2111400" y="1430280"/>
              <a:ext cx="0" cy="19670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2073240" y="335592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2235240" y="3325680"/>
              <a:ext cx="7128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flipV="1">
              <a:off x="2274840" y="1429920"/>
              <a:ext cx="0" cy="17924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2351520" y="3209760"/>
              <a:ext cx="160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4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flipV="1">
              <a:off x="2416320" y="1429920"/>
              <a:ext cx="0" cy="17924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2533680" y="3354480"/>
              <a:ext cx="71280" cy="7128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3040" bIns="-230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flipV="1">
              <a:off x="2571840" y="1031400"/>
              <a:ext cx="0" cy="233388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2588760" y="3206880"/>
              <a:ext cx="160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4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2662200" y="969480"/>
              <a:ext cx="0" cy="225108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2763720" y="3354480"/>
              <a:ext cx="71640" cy="7128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3040" bIns="-230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2801880" y="877680"/>
              <a:ext cx="0" cy="247788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2921040" y="3325680"/>
              <a:ext cx="9036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2968560" y="2995560"/>
              <a:ext cx="0" cy="22392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 flipV="1">
              <a:off x="3132000" y="2903400"/>
              <a:ext cx="0" cy="47952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309888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 flipV="1">
              <a:off x="3665520" y="2625480"/>
              <a:ext cx="0" cy="76356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3632040" y="335592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4008240" y="3471840"/>
              <a:ext cx="26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2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 flipV="1">
              <a:off x="4064040" y="2332080"/>
              <a:ext cx="0" cy="106200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402588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4067640" y="3605040"/>
              <a:ext cx="26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2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 flipV="1">
              <a:off x="4145040" y="2255760"/>
              <a:ext cx="0" cy="113976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410688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4194000" y="3354480"/>
              <a:ext cx="71640" cy="7128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3040" bIns="-230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 flipV="1">
              <a:off x="4232160" y="2251080"/>
              <a:ext cx="0" cy="110160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 flipV="1">
              <a:off x="4317840" y="2254320"/>
              <a:ext cx="0" cy="113976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428004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 flipV="1">
              <a:off x="4398840" y="2255760"/>
              <a:ext cx="0" cy="113976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436104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161460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1744560" y="401148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196056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207648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2238480" y="3979800"/>
              <a:ext cx="7128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2924280" y="3979800"/>
              <a:ext cx="9036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4476960" y="36050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flipV="1">
              <a:off x="4529160" y="2097000"/>
              <a:ext cx="0" cy="127800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4495680" y="335592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 flipV="1">
              <a:off x="4738680" y="1895400"/>
              <a:ext cx="0" cy="149400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4705200" y="335592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5178240" y="320688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5180040" y="3325680"/>
              <a:ext cx="10800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 flipV="1">
              <a:off x="5237280" y="1190520"/>
              <a:ext cx="0" cy="157032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5351040" y="320688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5376960" y="3325680"/>
              <a:ext cx="5400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 flipV="1">
              <a:off x="5235480" y="2947680"/>
              <a:ext cx="0" cy="2588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 flipV="1">
              <a:off x="5408640" y="1185840"/>
              <a:ext cx="0" cy="128592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 flipV="1">
              <a:off x="5407200" y="2943360"/>
              <a:ext cx="0" cy="25848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5554440" y="320184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5570640" y="3325680"/>
              <a:ext cx="8244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 flipV="1">
              <a:off x="5607000" y="1182600"/>
              <a:ext cx="0" cy="9302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 flipV="1">
              <a:off x="5605560" y="2937960"/>
              <a:ext cx="0" cy="2588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 flipV="1">
              <a:off x="5716440" y="2917440"/>
              <a:ext cx="0" cy="4856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568332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 flipV="1">
              <a:off x="5716440" y="1182600"/>
              <a:ext cx="0" cy="9302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6004800" y="34718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flipV="1">
              <a:off x="6048360" y="2760480"/>
              <a:ext cx="0" cy="64260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6014880" y="335592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 flipV="1">
              <a:off x="6048360" y="1360440"/>
              <a:ext cx="0" cy="23040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6108840" y="36050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 flipV="1">
              <a:off x="6154560" y="2760480"/>
              <a:ext cx="0" cy="64260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612144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 flipV="1">
              <a:off x="6154560" y="1176120"/>
              <a:ext cx="0" cy="40788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6212160" y="373860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 flipV="1">
              <a:off x="6257880" y="2760480"/>
              <a:ext cx="0" cy="64260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622476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 flipV="1">
              <a:off x="6257880" y="1089000"/>
              <a:ext cx="0" cy="49680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 flipV="1">
              <a:off x="6378480" y="2111040"/>
              <a:ext cx="0" cy="12920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634536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 flipV="1">
              <a:off x="6378480" y="971280"/>
              <a:ext cx="0" cy="62532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6407280" y="36050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 flipV="1">
              <a:off x="6464160" y="2111040"/>
              <a:ext cx="0" cy="12920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6431040" y="335592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 flipV="1">
              <a:off x="6464160" y="971280"/>
              <a:ext cx="0" cy="62532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6494760" y="373860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 flipV="1">
              <a:off x="6551640" y="2111040"/>
              <a:ext cx="0" cy="12920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6518160" y="335592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 flipV="1">
              <a:off x="6551640" y="971280"/>
              <a:ext cx="0" cy="62532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6600600" y="320040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6616800" y="3325680"/>
              <a:ext cx="9036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 flipV="1">
              <a:off x="6651720" y="974880"/>
              <a:ext cx="0" cy="223488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6718320" y="3200400"/>
              <a:ext cx="160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6738840" y="3325680"/>
              <a:ext cx="12564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 flipV="1">
              <a:off x="6792840" y="768240"/>
              <a:ext cx="0" cy="221616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3097080" y="401148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363060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402444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410544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4278240" y="401148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4359240" y="401148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449424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470376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5178600" y="3979800"/>
              <a:ext cx="10764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5375160" y="3979800"/>
              <a:ext cx="5400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5568840" y="3979800"/>
              <a:ext cx="8280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5681520" y="401148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601344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6119640" y="401148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6222960" y="401148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6343560" y="401148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6429240" y="4011480"/>
              <a:ext cx="7164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6516720" y="4011480"/>
              <a:ext cx="71280" cy="7164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960" bIns="396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6615000" y="3979800"/>
              <a:ext cx="9072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6737400" y="3979800"/>
              <a:ext cx="12528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455760" y="5219640"/>
              <a:ext cx="5936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639360" y="502920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845640" y="502920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650880" y="5141880"/>
              <a:ext cx="7128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880920" y="5141880"/>
              <a:ext cx="71640" cy="716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763560" y="5175360"/>
              <a:ext cx="7164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979560" y="51753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1049400" y="5219640"/>
              <a:ext cx="1008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1065600" y="52754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2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1132200" y="541512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2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1408320" y="541512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3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1500480" y="554832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3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1595520" y="52754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3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1724400" y="541512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3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1284480" y="52754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2-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1216080" y="554832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2-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1068480" y="51753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1154160" y="51753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1220760" y="5175360"/>
              <a:ext cx="7164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1297080" y="51753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1427040" y="5175360"/>
              <a:ext cx="7164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1614600" y="51753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1744560" y="5175360"/>
              <a:ext cx="7164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1523880" y="5175360"/>
              <a:ext cx="7164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1856160" y="554832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3-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1960560" y="51753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2057400" y="5219640"/>
              <a:ext cx="292104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2674080" y="5416560"/>
              <a:ext cx="2750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(TG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2408760" y="5276880"/>
              <a:ext cx="3513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(TTTG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2222280" y="502776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3078360" y="527688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2912760" y="502452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2060640" y="527688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3-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2076480" y="51753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2238480" y="5141880"/>
              <a:ext cx="7128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2354760" y="5027760"/>
              <a:ext cx="160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4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2536920" y="5167440"/>
              <a:ext cx="71280" cy="7128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3040" bIns="-230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2592000" y="5024520"/>
              <a:ext cx="160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4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2766960" y="5167440"/>
              <a:ext cx="71640" cy="7128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3040" bIns="-230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2924280" y="5141880"/>
              <a:ext cx="9036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3102120" y="51753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4952880" y="5219640"/>
              <a:ext cx="19926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5662800" y="52736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6321600" y="52736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5178240" y="502128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5180040" y="5141880"/>
              <a:ext cx="10800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5351040" y="502128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5376960" y="5141880"/>
              <a:ext cx="5400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5554440" y="501660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5570640" y="5141880"/>
              <a:ext cx="8244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5683320" y="51753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6004800" y="52736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6014880" y="5175360"/>
              <a:ext cx="7164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6108840" y="541332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6121440" y="51753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6212160" y="554688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6224760" y="51753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6345360" y="51753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6407280" y="541332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6431040" y="517536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6494760" y="554688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8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6518160" y="5175360"/>
              <a:ext cx="7164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6600600" y="501480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6616800" y="5141880"/>
              <a:ext cx="90360" cy="71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6718320" y="5014800"/>
              <a:ext cx="1609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6738840" y="5141880"/>
              <a:ext cx="12564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6929280" y="5219640"/>
              <a:ext cx="1103400" cy="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725760" y="527544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2-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863640" y="541512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2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112680" y="4672080"/>
              <a:ext cx="8007480" cy="10364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 flipV="1">
              <a:off x="6792840" y="3022200"/>
              <a:ext cx="0" cy="1904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 flipV="1">
              <a:off x="5715000" y="1486080"/>
              <a:ext cx="144360" cy="149040"/>
            </a:xfrm>
            <a:prstGeom prst="line">
              <a:avLst/>
            </a:prstGeom>
            <a:ln w="144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3630600" y="517860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3610080" y="527688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501480" y="5141880"/>
              <a:ext cx="9072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174600" y="5221440"/>
              <a:ext cx="304920" cy="0"/>
            </a:xfrm>
            <a:prstGeom prst="line">
              <a:avLst/>
            </a:prstGeom>
            <a:ln w="19080">
              <a:solidFill>
                <a:srgbClr val="000000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488520" y="5029200"/>
              <a:ext cx="107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Times New Roman"/>
                </a:rPr>
                <a:t>E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4025880" y="517860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4106880" y="517860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4270320" y="5178600"/>
              <a:ext cx="7164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4115160" y="5548320"/>
              <a:ext cx="26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2C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3935160" y="5276880"/>
              <a:ext cx="26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2A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4032720" y="5415120"/>
              <a:ext cx="26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2B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4368960" y="517860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4494240" y="517860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4703760" y="5178600"/>
              <a:ext cx="71280" cy="71280"/>
            </a:xfrm>
            <a:prstGeom prst="ellips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3600" bIns="36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4360320" y="5276880"/>
              <a:ext cx="267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2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4686480" y="554832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4486320" y="5415120"/>
              <a:ext cx="214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I5-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615960" y="4675320"/>
              <a:ext cx="0" cy="1036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1062000" y="4672080"/>
              <a:ext cx="0" cy="1036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2062080" y="4675320"/>
              <a:ext cx="0" cy="1036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150480" y="4687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663120" y="4687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1118880" y="4687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2108520" y="4687920"/>
              <a:ext cx="30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4 &amp; 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3611160" y="47545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4412880" y="4687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5117760" y="46879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4354560" y="4672080"/>
              <a:ext cx="0" cy="1036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5008680" y="4672080"/>
              <a:ext cx="0" cy="1036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111960" y="4444920"/>
              <a:ext cx="21448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BOVINE GENOMIC CONTIG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111600" y="23760"/>
              <a:ext cx="16452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BAC CLONES CONTIG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4191120" y="5175360"/>
              <a:ext cx="71280" cy="71280"/>
            </a:xfrm>
            <a:prstGeom prst="triangle">
              <a:avLst>
                <a:gd name="adj" fmla="val 50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-23040" bIns="-230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3792960" y="5541840"/>
              <a:ext cx="3513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Times New Roman"/>
                </a:rPr>
                <a:t>(TTTG)</a:t>
              </a:r>
              <a:r>
                <a:rPr b="0" lang="en-US" sz="700" spc="-1" strike="noStrike" baseline="-25000">
                  <a:solidFill>
                    <a:srgbClr val="000000"/>
                  </a:solidFill>
                  <a:latin typeface="Times New Roman"/>
                </a:rPr>
                <a:t>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4219560" y="5276880"/>
              <a:ext cx="0" cy="111240"/>
            </a:xfrm>
            <a:prstGeom prst="line">
              <a:avLst/>
            </a:prstGeom>
            <a:ln cap="rnd" w="6480">
              <a:solidFill>
                <a:srgbClr val="0000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 flipH="1">
              <a:off x="3928680" y="5391000"/>
              <a:ext cx="291960" cy="0"/>
            </a:xfrm>
            <a:prstGeom prst="line">
              <a:avLst/>
            </a:prstGeom>
            <a:ln cap="rnd" w="9360">
              <a:solidFill>
                <a:srgbClr val="0000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3929040" y="5396040"/>
              <a:ext cx="0" cy="110880"/>
            </a:xfrm>
            <a:prstGeom prst="line">
              <a:avLst/>
            </a:prstGeom>
            <a:ln cap="rnd" w="6480">
              <a:solidFill>
                <a:srgbClr val="000000"/>
              </a:solidFill>
              <a:custDash>
                <a:ds d="100000" sp="1000"/>
              </a:custDash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5-18T08:21:54Z</dcterms:created>
  <dc:creator>Luca Ferretti</dc:creator>
  <dc:description/>
  <dc:language>en-US</dc:language>
  <cp:lastModifiedBy>Luca Ferretti</cp:lastModifiedBy>
  <dcterms:modified xsi:type="dcterms:W3CDTF">2006-05-19T09:46:12Z</dcterms:modified>
  <cp:revision>4</cp:revision>
  <dc:subject/>
  <dc:title>Presentazione di PowerPoint</dc:title>
</cp:coreProperties>
</file>